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65" r:id="rId2"/>
  </p:sldIdLst>
  <p:sldSz cx="6254750" cy="8458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. Figure 5" id="{8FCDD8C4-EC9B-48D3-B5CE-629FBB9EB8EF}">
          <p14:sldIdLst>
            <p14:sldId id="265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ER" initials="U" lastIdx="9" clrIdx="0">
    <p:extLst>
      <p:ext uri="{19B8F6BF-5375-455C-9EA6-DF929625EA0E}">
        <p15:presenceInfo xmlns:p15="http://schemas.microsoft.com/office/powerpoint/2012/main" userId="USER" providerId="None"/>
      </p:ext>
    </p:extLst>
  </p:cmAuthor>
  <p:cmAuthor id="2" name="skarimi" initials="s" lastIdx="4" clrIdx="1">
    <p:extLst>
      <p:ext uri="{19B8F6BF-5375-455C-9EA6-DF929625EA0E}">
        <p15:presenceInfo xmlns:p15="http://schemas.microsoft.com/office/powerpoint/2012/main" userId="skarimi" providerId="None"/>
      </p:ext>
    </p:extLst>
  </p:cmAuthor>
  <p:cmAuthor id="3" name="soheila karimi" initials="sk" lastIdx="6" clrIdx="2">
    <p:extLst>
      <p:ext uri="{19B8F6BF-5375-455C-9EA6-DF929625EA0E}">
        <p15:presenceInfo xmlns:p15="http://schemas.microsoft.com/office/powerpoint/2012/main" userId="bb0168d6462bdfd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AD222"/>
    <a:srgbClr val="EAB200"/>
    <a:srgbClr val="EA6B14"/>
    <a:srgbClr val="3333FF"/>
    <a:srgbClr val="00FF00"/>
    <a:srgbClr val="1DFF1D"/>
    <a:srgbClr val="000300"/>
    <a:srgbClr val="66A2D8"/>
    <a:srgbClr val="84B4E0"/>
    <a:srgbClr val="5F5FD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26" autoAdjust="0"/>
    <p:restoredTop sz="86861" autoAdjust="0"/>
  </p:normalViewPr>
  <p:slideViewPr>
    <p:cSldViewPr snapToGrid="0">
      <p:cViewPr varScale="1">
        <p:scale>
          <a:sx n="60" d="100"/>
          <a:sy n="60" d="100"/>
        </p:scale>
        <p:origin x="227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karinas.scrc.umanitoba.ca\Ghazaleh\cell%20culture%20images\NPCs%20experiments\Migration%20assay-NPCs-7.05.2018\Counting-N3-8.5.201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3051618547681538E-2"/>
          <c:y val="5.6030183727034118E-2"/>
          <c:w val="0.9115393700787402"/>
          <c:h val="0.77611475648877226"/>
        </c:manualLayout>
      </c:layout>
      <c:barChart>
        <c:barDir val="col"/>
        <c:grouping val="clustered"/>
        <c:varyColors val="0"/>
        <c:ser>
          <c:idx val="0"/>
          <c:order val="0"/>
          <c:spPr>
            <a:ln w="3175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C00000"/>
              </a:solidFill>
              <a:ln w="317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2520-4698-BE42-45D36802DC6E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20000"/>
                  <a:lumOff val="80000"/>
                </a:schemeClr>
              </a:solidFill>
              <a:ln w="317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2520-4698-BE42-45D36802DC6E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317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2520-4698-BE42-45D36802DC6E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20000"/>
                  <a:lumOff val="80000"/>
                </a:schemeClr>
              </a:solidFill>
              <a:ln w="317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2520-4698-BE42-45D36802DC6E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3175"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2520-4698-BE42-45D36802DC6E}"/>
              </c:ext>
            </c:extLst>
          </c:dPt>
          <c:errBars>
            <c:errBarType val="plus"/>
            <c:errValType val="cust"/>
            <c:noEndCap val="0"/>
            <c:plus>
              <c:numRef>
                <c:f>'[Counting-N3-8.5.2018.xlsx]Sheet3'!$E$22:$E$26</c:f>
                <c:numCache>
                  <c:formatCode>General</c:formatCode>
                  <c:ptCount val="5"/>
                  <c:pt idx="0">
                    <c:v>0.13758648608153118</c:v>
                  </c:pt>
                  <c:pt idx="1">
                    <c:v>0.24286809349266678</c:v>
                  </c:pt>
                  <c:pt idx="2">
                    <c:v>0.54148857471160905</c:v>
                  </c:pt>
                  <c:pt idx="3">
                    <c:v>0.52247170295058831</c:v>
                  </c:pt>
                  <c:pt idx="4">
                    <c:v>1.2656916325242795</c:v>
                  </c:pt>
                </c:numCache>
              </c:numRef>
            </c:plus>
            <c:minus>
              <c:numRef>
                <c:f>'[Counting-N3-8.5.2018.xlsx]Sheet3'!$E$22:$E$26</c:f>
                <c:numCache>
                  <c:formatCode>General</c:formatCode>
                  <c:ptCount val="5"/>
                  <c:pt idx="0">
                    <c:v>0.13758648608153118</c:v>
                  </c:pt>
                  <c:pt idx="1">
                    <c:v>0.24286809349266678</c:v>
                  </c:pt>
                  <c:pt idx="2">
                    <c:v>0.54148857471160905</c:v>
                  </c:pt>
                  <c:pt idx="3">
                    <c:v>0.52247170295058831</c:v>
                  </c:pt>
                  <c:pt idx="4">
                    <c:v>1.2656916325242795</c:v>
                  </c:pt>
                </c:numCache>
              </c:numRef>
            </c:minus>
          </c:errBars>
          <c:cat>
            <c:strRef>
              <c:f>'[Counting-N3-8.5.2018.xlsx]Sheet3'!$C$22:$C$26</c:f>
              <c:strCache>
                <c:ptCount val="5"/>
                <c:pt idx="0">
                  <c:v>Control media</c:v>
                </c:pt>
                <c:pt idx="1">
                  <c:v>Incubated Nrg-1 50 ng/ml</c:v>
                </c:pt>
                <c:pt idx="2">
                  <c:v>Fresh Nrg-1 50 ng/ml</c:v>
                </c:pt>
                <c:pt idx="3">
                  <c:v>Incubated Nrg-1 200 ng/ml</c:v>
                </c:pt>
                <c:pt idx="4">
                  <c:v>Fresh Nrg-1 200 ng/ml</c:v>
                </c:pt>
              </c:strCache>
            </c:strRef>
          </c:cat>
          <c:val>
            <c:numRef>
              <c:f>'[Counting-N3-8.5.2018.xlsx]Sheet3'!$D$22:$D$26</c:f>
              <c:numCache>
                <c:formatCode>General</c:formatCode>
                <c:ptCount val="5"/>
                <c:pt idx="0">
                  <c:v>1</c:v>
                </c:pt>
                <c:pt idx="1">
                  <c:v>1.1851851851851851</c:v>
                </c:pt>
                <c:pt idx="2">
                  <c:v>3.1666666666666665</c:v>
                </c:pt>
                <c:pt idx="3">
                  <c:v>1.8518518518518521</c:v>
                </c:pt>
                <c:pt idx="4">
                  <c:v>4.8222222222222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2520-4698-BE42-45D36802DC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8960808"/>
        <c:axId val="348957672"/>
      </c:barChart>
      <c:catAx>
        <c:axId val="3489608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400" b="1">
                <a:noFill/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348957672"/>
        <c:crosses val="autoZero"/>
        <c:auto val="1"/>
        <c:lblAlgn val="ctr"/>
        <c:lblOffset val="100"/>
        <c:noMultiLvlLbl val="0"/>
      </c:catAx>
      <c:valAx>
        <c:axId val="3489576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100" b="1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en-US"/>
          </a:p>
        </c:txPr>
        <c:crossAx val="348960808"/>
        <c:crosses val="autoZero"/>
        <c:crossBetween val="between"/>
      </c:valAx>
    </c:plotArea>
    <c:plotVisOnly val="1"/>
    <c:dispBlanksAs val="gap"/>
    <c:showDLblsOverMax val="0"/>
  </c:chart>
  <c:spPr>
    <a:noFill/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817B45-D4D3-45CB-934D-97DF67DE9D2D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87588" y="1143000"/>
            <a:ext cx="22828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B61A00-9F51-4288-915B-64876428B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1738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1pPr>
    <a:lvl2pPr marL="368046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2pPr>
    <a:lvl3pPr marL="736092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3pPr>
    <a:lvl4pPr marL="1104138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4pPr>
    <a:lvl5pPr marL="1472184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5pPr>
    <a:lvl6pPr marL="1840230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6pPr>
    <a:lvl7pPr marL="2208276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7pPr>
    <a:lvl8pPr marL="2576322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8pPr>
    <a:lvl9pPr marL="2944368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106" y="1384248"/>
            <a:ext cx="5316538" cy="2944707"/>
          </a:xfrm>
        </p:spPr>
        <p:txBody>
          <a:bodyPr anchor="b"/>
          <a:lstStyle>
            <a:lvl1pPr algn="ctr">
              <a:defRPr sz="410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1844" y="4442514"/>
            <a:ext cx="4691063" cy="2042106"/>
          </a:xfrm>
        </p:spPr>
        <p:txBody>
          <a:bodyPr/>
          <a:lstStyle>
            <a:lvl1pPr marL="0" indent="0" algn="ctr">
              <a:buNone/>
              <a:defRPr sz="1642"/>
            </a:lvl1pPr>
            <a:lvl2pPr marL="312725" indent="0" algn="ctr">
              <a:buNone/>
              <a:defRPr sz="1368"/>
            </a:lvl2pPr>
            <a:lvl3pPr marL="625450" indent="0" algn="ctr">
              <a:buNone/>
              <a:defRPr sz="1231"/>
            </a:lvl3pPr>
            <a:lvl4pPr marL="938174" indent="0" algn="ctr">
              <a:buNone/>
              <a:defRPr sz="1094"/>
            </a:lvl4pPr>
            <a:lvl5pPr marL="1250899" indent="0" algn="ctr">
              <a:buNone/>
              <a:defRPr sz="1094"/>
            </a:lvl5pPr>
            <a:lvl6pPr marL="1563624" indent="0" algn="ctr">
              <a:buNone/>
              <a:defRPr sz="1094"/>
            </a:lvl6pPr>
            <a:lvl7pPr marL="1876349" indent="0" algn="ctr">
              <a:buNone/>
              <a:defRPr sz="1094"/>
            </a:lvl7pPr>
            <a:lvl8pPr marL="2189074" indent="0" algn="ctr">
              <a:buNone/>
              <a:defRPr sz="1094"/>
            </a:lvl8pPr>
            <a:lvl9pPr marL="2501798" indent="0" algn="ctr">
              <a:buNone/>
              <a:defRPr sz="109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567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255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76056" y="450321"/>
            <a:ext cx="1348680" cy="71679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014" y="450321"/>
            <a:ext cx="3967857" cy="716793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92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468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6757" y="2108679"/>
            <a:ext cx="5394722" cy="3518376"/>
          </a:xfrm>
        </p:spPr>
        <p:txBody>
          <a:bodyPr anchor="b"/>
          <a:lstStyle>
            <a:lvl1pPr>
              <a:defRPr sz="410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6757" y="5660339"/>
            <a:ext cx="5394722" cy="1850231"/>
          </a:xfrm>
        </p:spPr>
        <p:txBody>
          <a:bodyPr/>
          <a:lstStyle>
            <a:lvl1pPr marL="0" indent="0">
              <a:buNone/>
              <a:defRPr sz="1642">
                <a:solidFill>
                  <a:schemeClr val="tx1"/>
                </a:solidFill>
              </a:defRPr>
            </a:lvl1pPr>
            <a:lvl2pPr marL="312725" indent="0">
              <a:buNone/>
              <a:defRPr sz="1368">
                <a:solidFill>
                  <a:schemeClr val="tx1">
                    <a:tint val="75000"/>
                  </a:schemeClr>
                </a:solidFill>
              </a:defRPr>
            </a:lvl2pPr>
            <a:lvl3pPr marL="625450" indent="0">
              <a:buNone/>
              <a:defRPr sz="1231">
                <a:solidFill>
                  <a:schemeClr val="tx1">
                    <a:tint val="75000"/>
                  </a:schemeClr>
                </a:solidFill>
              </a:defRPr>
            </a:lvl3pPr>
            <a:lvl4pPr marL="938174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4pPr>
            <a:lvl5pPr marL="1250899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5pPr>
            <a:lvl6pPr marL="1563624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6pPr>
            <a:lvl7pPr marL="1876349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7pPr>
            <a:lvl8pPr marL="2189074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8pPr>
            <a:lvl9pPr marL="2501798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533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014" y="2251604"/>
            <a:ext cx="2658269" cy="536665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66467" y="2251604"/>
            <a:ext cx="2658269" cy="536665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730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829" y="450323"/>
            <a:ext cx="5394722" cy="163486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829" y="2073434"/>
            <a:ext cx="2646052" cy="1016158"/>
          </a:xfrm>
        </p:spPr>
        <p:txBody>
          <a:bodyPr anchor="b"/>
          <a:lstStyle>
            <a:lvl1pPr marL="0" indent="0">
              <a:buNone/>
              <a:defRPr sz="1642" b="1"/>
            </a:lvl1pPr>
            <a:lvl2pPr marL="312725" indent="0">
              <a:buNone/>
              <a:defRPr sz="1368" b="1"/>
            </a:lvl2pPr>
            <a:lvl3pPr marL="625450" indent="0">
              <a:buNone/>
              <a:defRPr sz="1231" b="1"/>
            </a:lvl3pPr>
            <a:lvl4pPr marL="938174" indent="0">
              <a:buNone/>
              <a:defRPr sz="1094" b="1"/>
            </a:lvl4pPr>
            <a:lvl5pPr marL="1250899" indent="0">
              <a:buNone/>
              <a:defRPr sz="1094" b="1"/>
            </a:lvl5pPr>
            <a:lvl6pPr marL="1563624" indent="0">
              <a:buNone/>
              <a:defRPr sz="1094" b="1"/>
            </a:lvl6pPr>
            <a:lvl7pPr marL="1876349" indent="0">
              <a:buNone/>
              <a:defRPr sz="1094" b="1"/>
            </a:lvl7pPr>
            <a:lvl8pPr marL="2189074" indent="0">
              <a:buNone/>
              <a:defRPr sz="1094" b="1"/>
            </a:lvl8pPr>
            <a:lvl9pPr marL="2501798" indent="0">
              <a:buNone/>
              <a:defRPr sz="109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0829" y="3089593"/>
            <a:ext cx="2646052" cy="45443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66468" y="2073434"/>
            <a:ext cx="2659083" cy="1016158"/>
          </a:xfrm>
        </p:spPr>
        <p:txBody>
          <a:bodyPr anchor="b"/>
          <a:lstStyle>
            <a:lvl1pPr marL="0" indent="0">
              <a:buNone/>
              <a:defRPr sz="1642" b="1"/>
            </a:lvl1pPr>
            <a:lvl2pPr marL="312725" indent="0">
              <a:buNone/>
              <a:defRPr sz="1368" b="1"/>
            </a:lvl2pPr>
            <a:lvl3pPr marL="625450" indent="0">
              <a:buNone/>
              <a:defRPr sz="1231" b="1"/>
            </a:lvl3pPr>
            <a:lvl4pPr marL="938174" indent="0">
              <a:buNone/>
              <a:defRPr sz="1094" b="1"/>
            </a:lvl4pPr>
            <a:lvl5pPr marL="1250899" indent="0">
              <a:buNone/>
              <a:defRPr sz="1094" b="1"/>
            </a:lvl5pPr>
            <a:lvl6pPr marL="1563624" indent="0">
              <a:buNone/>
              <a:defRPr sz="1094" b="1"/>
            </a:lvl6pPr>
            <a:lvl7pPr marL="1876349" indent="0">
              <a:buNone/>
              <a:defRPr sz="1094" b="1"/>
            </a:lvl7pPr>
            <a:lvl8pPr marL="2189074" indent="0">
              <a:buNone/>
              <a:defRPr sz="1094" b="1"/>
            </a:lvl8pPr>
            <a:lvl9pPr marL="2501798" indent="0">
              <a:buNone/>
              <a:defRPr sz="109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66468" y="3089593"/>
            <a:ext cx="2659083" cy="45443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177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000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015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829" y="563880"/>
            <a:ext cx="2017320" cy="1973580"/>
          </a:xfrm>
        </p:spPr>
        <p:txBody>
          <a:bodyPr anchor="b"/>
          <a:lstStyle>
            <a:lvl1pPr>
              <a:defRPr sz="21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59084" y="1217826"/>
            <a:ext cx="3166467" cy="6010804"/>
          </a:xfrm>
        </p:spPr>
        <p:txBody>
          <a:bodyPr/>
          <a:lstStyle>
            <a:lvl1pPr>
              <a:defRPr sz="2189"/>
            </a:lvl1pPr>
            <a:lvl2pPr>
              <a:defRPr sz="1915"/>
            </a:lvl2pPr>
            <a:lvl3pPr>
              <a:defRPr sz="1642"/>
            </a:lvl3pPr>
            <a:lvl4pPr>
              <a:defRPr sz="1368"/>
            </a:lvl4pPr>
            <a:lvl5pPr>
              <a:defRPr sz="1368"/>
            </a:lvl5pPr>
            <a:lvl6pPr>
              <a:defRPr sz="1368"/>
            </a:lvl6pPr>
            <a:lvl7pPr>
              <a:defRPr sz="1368"/>
            </a:lvl7pPr>
            <a:lvl8pPr>
              <a:defRPr sz="1368"/>
            </a:lvl8pPr>
            <a:lvl9pPr>
              <a:defRPr sz="1368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0829" y="2537460"/>
            <a:ext cx="2017320" cy="4700959"/>
          </a:xfrm>
        </p:spPr>
        <p:txBody>
          <a:bodyPr/>
          <a:lstStyle>
            <a:lvl1pPr marL="0" indent="0">
              <a:buNone/>
              <a:defRPr sz="1094"/>
            </a:lvl1pPr>
            <a:lvl2pPr marL="312725" indent="0">
              <a:buNone/>
              <a:defRPr sz="958"/>
            </a:lvl2pPr>
            <a:lvl3pPr marL="625450" indent="0">
              <a:buNone/>
              <a:defRPr sz="821"/>
            </a:lvl3pPr>
            <a:lvl4pPr marL="938174" indent="0">
              <a:buNone/>
              <a:defRPr sz="684"/>
            </a:lvl4pPr>
            <a:lvl5pPr marL="1250899" indent="0">
              <a:buNone/>
              <a:defRPr sz="684"/>
            </a:lvl5pPr>
            <a:lvl6pPr marL="1563624" indent="0">
              <a:buNone/>
              <a:defRPr sz="684"/>
            </a:lvl6pPr>
            <a:lvl7pPr marL="1876349" indent="0">
              <a:buNone/>
              <a:defRPr sz="684"/>
            </a:lvl7pPr>
            <a:lvl8pPr marL="2189074" indent="0">
              <a:buNone/>
              <a:defRPr sz="684"/>
            </a:lvl8pPr>
            <a:lvl9pPr marL="2501798" indent="0">
              <a:buNone/>
              <a:defRPr sz="68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842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829" y="563880"/>
            <a:ext cx="2017320" cy="1973580"/>
          </a:xfrm>
        </p:spPr>
        <p:txBody>
          <a:bodyPr anchor="b"/>
          <a:lstStyle>
            <a:lvl1pPr>
              <a:defRPr sz="21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59084" y="1217826"/>
            <a:ext cx="3166467" cy="6010804"/>
          </a:xfrm>
        </p:spPr>
        <p:txBody>
          <a:bodyPr anchor="t"/>
          <a:lstStyle>
            <a:lvl1pPr marL="0" indent="0">
              <a:buNone/>
              <a:defRPr sz="2189"/>
            </a:lvl1pPr>
            <a:lvl2pPr marL="312725" indent="0">
              <a:buNone/>
              <a:defRPr sz="1915"/>
            </a:lvl2pPr>
            <a:lvl3pPr marL="625450" indent="0">
              <a:buNone/>
              <a:defRPr sz="1642"/>
            </a:lvl3pPr>
            <a:lvl4pPr marL="938174" indent="0">
              <a:buNone/>
              <a:defRPr sz="1368"/>
            </a:lvl4pPr>
            <a:lvl5pPr marL="1250899" indent="0">
              <a:buNone/>
              <a:defRPr sz="1368"/>
            </a:lvl5pPr>
            <a:lvl6pPr marL="1563624" indent="0">
              <a:buNone/>
              <a:defRPr sz="1368"/>
            </a:lvl6pPr>
            <a:lvl7pPr marL="1876349" indent="0">
              <a:buNone/>
              <a:defRPr sz="1368"/>
            </a:lvl7pPr>
            <a:lvl8pPr marL="2189074" indent="0">
              <a:buNone/>
              <a:defRPr sz="1368"/>
            </a:lvl8pPr>
            <a:lvl9pPr marL="2501798" indent="0">
              <a:buNone/>
              <a:defRPr sz="136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0829" y="2537460"/>
            <a:ext cx="2017320" cy="4700959"/>
          </a:xfrm>
        </p:spPr>
        <p:txBody>
          <a:bodyPr/>
          <a:lstStyle>
            <a:lvl1pPr marL="0" indent="0">
              <a:buNone/>
              <a:defRPr sz="1094"/>
            </a:lvl1pPr>
            <a:lvl2pPr marL="312725" indent="0">
              <a:buNone/>
              <a:defRPr sz="958"/>
            </a:lvl2pPr>
            <a:lvl3pPr marL="625450" indent="0">
              <a:buNone/>
              <a:defRPr sz="821"/>
            </a:lvl3pPr>
            <a:lvl4pPr marL="938174" indent="0">
              <a:buNone/>
              <a:defRPr sz="684"/>
            </a:lvl4pPr>
            <a:lvl5pPr marL="1250899" indent="0">
              <a:buNone/>
              <a:defRPr sz="684"/>
            </a:lvl5pPr>
            <a:lvl6pPr marL="1563624" indent="0">
              <a:buNone/>
              <a:defRPr sz="684"/>
            </a:lvl6pPr>
            <a:lvl7pPr marL="1876349" indent="0">
              <a:buNone/>
              <a:defRPr sz="684"/>
            </a:lvl7pPr>
            <a:lvl8pPr marL="2189074" indent="0">
              <a:buNone/>
              <a:defRPr sz="684"/>
            </a:lvl8pPr>
            <a:lvl9pPr marL="2501798" indent="0">
              <a:buNone/>
              <a:defRPr sz="68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03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014" y="450323"/>
            <a:ext cx="5394722" cy="16348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014" y="2251604"/>
            <a:ext cx="5394722" cy="53666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014" y="7839500"/>
            <a:ext cx="1407319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1886" y="7839500"/>
            <a:ext cx="2110978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17417" y="7839500"/>
            <a:ext cx="1407319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293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25450" rtl="0" eaLnBrk="1" latinLnBrk="0" hangingPunct="1">
        <a:lnSpc>
          <a:spcPct val="90000"/>
        </a:lnSpc>
        <a:spcBef>
          <a:spcPct val="0"/>
        </a:spcBef>
        <a:buNone/>
        <a:defRPr sz="30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362" indent="-156362" algn="l" defTabSz="625450" rtl="0" eaLnBrk="1" latinLnBrk="0" hangingPunct="1">
        <a:lnSpc>
          <a:spcPct val="90000"/>
        </a:lnSpc>
        <a:spcBef>
          <a:spcPts val="684"/>
        </a:spcBef>
        <a:buFont typeface="Arial" panose="020B0604020202020204" pitchFamily="34" charset="0"/>
        <a:buChar char="•"/>
        <a:defRPr sz="1915" kern="1200">
          <a:solidFill>
            <a:schemeClr val="tx1"/>
          </a:solidFill>
          <a:latin typeface="+mn-lt"/>
          <a:ea typeface="+mn-ea"/>
          <a:cs typeface="+mn-cs"/>
        </a:defRPr>
      </a:lvl1pPr>
      <a:lvl2pPr marL="469087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642" kern="1200">
          <a:solidFill>
            <a:schemeClr val="tx1"/>
          </a:solidFill>
          <a:latin typeface="+mn-lt"/>
          <a:ea typeface="+mn-ea"/>
          <a:cs typeface="+mn-cs"/>
        </a:defRPr>
      </a:lvl2pPr>
      <a:lvl3pPr marL="781812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368" kern="1200">
          <a:solidFill>
            <a:schemeClr val="tx1"/>
          </a:solidFill>
          <a:latin typeface="+mn-lt"/>
          <a:ea typeface="+mn-ea"/>
          <a:cs typeface="+mn-cs"/>
        </a:defRPr>
      </a:lvl3pPr>
      <a:lvl4pPr marL="1094537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4pPr>
      <a:lvl5pPr marL="1407262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5pPr>
      <a:lvl6pPr marL="1719986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6pPr>
      <a:lvl7pPr marL="2032711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7pPr>
      <a:lvl8pPr marL="2345436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8pPr>
      <a:lvl9pPr marL="2658161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1pPr>
      <a:lvl2pPr marL="312725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2pPr>
      <a:lvl3pPr marL="625450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3pPr>
      <a:lvl4pPr marL="938174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4pPr>
      <a:lvl5pPr marL="1250899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5pPr>
      <a:lvl6pPr marL="1563624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6pPr>
      <a:lvl7pPr marL="1876349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7pPr>
      <a:lvl8pPr marL="2189074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8pPr>
      <a:lvl9pPr marL="2501798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4" name="Group 73"/>
          <p:cNvGrpSpPr/>
          <p:nvPr/>
        </p:nvGrpSpPr>
        <p:grpSpPr>
          <a:xfrm>
            <a:off x="314363" y="2903612"/>
            <a:ext cx="4832226" cy="2650976"/>
            <a:chOff x="246906" y="4738578"/>
            <a:chExt cx="8139540" cy="4339477"/>
          </a:xfrm>
        </p:grpSpPr>
        <p:pic>
          <p:nvPicPr>
            <p:cNvPr id="51" name="Picture 50"/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17566" y="4804159"/>
              <a:ext cx="4245805" cy="4273896"/>
            </a:xfrm>
            <a:prstGeom prst="rect">
              <a:avLst/>
            </a:prstGeom>
          </p:spPr>
        </p:pic>
        <p:grpSp>
          <p:nvGrpSpPr>
            <p:cNvPr id="20" name="Group 19"/>
            <p:cNvGrpSpPr/>
            <p:nvPr/>
          </p:nvGrpSpPr>
          <p:grpSpPr>
            <a:xfrm>
              <a:off x="1573841" y="5186911"/>
              <a:ext cx="6812605" cy="3212326"/>
              <a:chOff x="1126212" y="5750867"/>
              <a:chExt cx="6812605" cy="3212326"/>
            </a:xfrm>
          </p:grpSpPr>
          <p:sp>
            <p:nvSpPr>
              <p:cNvPr id="34" name="Right Brace 33"/>
              <p:cNvSpPr/>
              <p:nvPr/>
            </p:nvSpPr>
            <p:spPr>
              <a:xfrm>
                <a:off x="4875959" y="5750867"/>
                <a:ext cx="246254" cy="1032630"/>
              </a:xfrm>
              <a:prstGeom prst="rightBrac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1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cxnSp>
            <p:nvCxnSpPr>
              <p:cNvPr id="35" name="Straight Connector 34"/>
              <p:cNvCxnSpPr/>
              <p:nvPr/>
            </p:nvCxnSpPr>
            <p:spPr>
              <a:xfrm flipH="1">
                <a:off x="3655924" y="5756636"/>
                <a:ext cx="1250177" cy="0"/>
              </a:xfrm>
              <a:prstGeom prst="line">
                <a:avLst/>
              </a:prstGeom>
              <a:ln w="19050">
                <a:solidFill>
                  <a:srgbClr val="FF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 flipH="1">
                <a:off x="3652736" y="6797263"/>
                <a:ext cx="1188803" cy="0"/>
              </a:xfrm>
              <a:prstGeom prst="line">
                <a:avLst/>
              </a:prstGeom>
              <a:ln w="19050">
                <a:solidFill>
                  <a:srgbClr val="FF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 flipH="1">
                <a:off x="3631860" y="6894016"/>
                <a:ext cx="1200525" cy="0"/>
              </a:xfrm>
              <a:prstGeom prst="line">
                <a:avLst/>
              </a:prstGeom>
              <a:ln w="19050">
                <a:solidFill>
                  <a:srgbClr val="00B05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 flipH="1">
                <a:off x="3631552" y="7710890"/>
                <a:ext cx="1200525" cy="0"/>
              </a:xfrm>
              <a:prstGeom prst="line">
                <a:avLst/>
              </a:prstGeom>
              <a:ln w="19050">
                <a:solidFill>
                  <a:srgbClr val="00B05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/>
              <p:cNvCxnSpPr/>
              <p:nvPr/>
            </p:nvCxnSpPr>
            <p:spPr>
              <a:xfrm flipH="1">
                <a:off x="3631552" y="7825812"/>
                <a:ext cx="1250177" cy="0"/>
              </a:xfrm>
              <a:prstGeom prst="line">
                <a:avLst/>
              </a:prstGeom>
              <a:ln w="19050">
                <a:solidFill>
                  <a:srgbClr val="FF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/>
              <p:cNvCxnSpPr/>
              <p:nvPr/>
            </p:nvCxnSpPr>
            <p:spPr>
              <a:xfrm flipH="1" flipV="1">
                <a:off x="3614065" y="8963192"/>
                <a:ext cx="1292036" cy="1"/>
              </a:xfrm>
              <a:prstGeom prst="line">
                <a:avLst/>
              </a:prstGeom>
              <a:ln w="19050">
                <a:solidFill>
                  <a:srgbClr val="FF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Box 40"/>
              <p:cNvSpPr txBox="1"/>
              <p:nvPr/>
            </p:nvSpPr>
            <p:spPr>
              <a:xfrm>
                <a:off x="5230485" y="6113293"/>
                <a:ext cx="2560401" cy="3790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Upper compartment</a:t>
                </a: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5230485" y="7143272"/>
                <a:ext cx="1760213" cy="3790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Capillaries</a:t>
                </a: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5192885" y="8196224"/>
                <a:ext cx="2745932" cy="3790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Lower compartment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1126212" y="5756128"/>
                <a:ext cx="440663" cy="42823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ii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2919677" y="5750867"/>
                <a:ext cx="375860" cy="42823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i</a:t>
                </a:r>
                <a:endPara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1216379" y="6797263"/>
                <a:ext cx="505467" cy="42823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iii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3066561" y="7902297"/>
                <a:ext cx="508169" cy="42823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iv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1151450" y="7982105"/>
                <a:ext cx="443365" cy="42823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v</a:t>
                </a:r>
              </a:p>
            </p:txBody>
          </p:sp>
          <p:sp>
            <p:nvSpPr>
              <p:cNvPr id="49" name="Right Brace 48"/>
              <p:cNvSpPr/>
              <p:nvPr/>
            </p:nvSpPr>
            <p:spPr>
              <a:xfrm>
                <a:off x="4875959" y="6894016"/>
                <a:ext cx="246254" cy="816874"/>
              </a:xfrm>
              <a:prstGeom prst="rightBrace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1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50" name="Right Brace 49"/>
              <p:cNvSpPr/>
              <p:nvPr/>
            </p:nvSpPr>
            <p:spPr>
              <a:xfrm>
                <a:off x="4961399" y="7823779"/>
                <a:ext cx="160814" cy="1139413"/>
              </a:xfrm>
              <a:prstGeom prst="rightBrac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1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76" name="TextBox 75"/>
            <p:cNvSpPr txBox="1"/>
            <p:nvPr/>
          </p:nvSpPr>
          <p:spPr>
            <a:xfrm>
              <a:off x="246906" y="4738578"/>
              <a:ext cx="613472" cy="4282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b)</a:t>
              </a: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3853088" y="1164678"/>
            <a:ext cx="2028605" cy="1133520"/>
            <a:chOff x="3853088" y="1164678"/>
            <a:chExt cx="2028605" cy="1133520"/>
          </a:xfrm>
        </p:grpSpPr>
        <p:sp>
          <p:nvSpPr>
            <p:cNvPr id="54" name="TextBox 53"/>
            <p:cNvSpPr txBox="1"/>
            <p:nvPr/>
          </p:nvSpPr>
          <p:spPr>
            <a:xfrm>
              <a:off x="4029904" y="1365152"/>
              <a:ext cx="17732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Incubated Nrg-1 50 ng/ml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029904" y="1581402"/>
              <a:ext cx="15151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Fresh Nrg-1 50 ng/ml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029904" y="1810879"/>
              <a:ext cx="185178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Incubated Nrg-1 200 ng/ml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029904" y="2036588"/>
              <a:ext cx="15937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Fresh Nrg-1 200 ng/ml</a:t>
              </a:r>
            </a:p>
          </p:txBody>
        </p:sp>
        <p:sp>
          <p:nvSpPr>
            <p:cNvPr id="58" name="Rectangle 57"/>
            <p:cNvSpPr/>
            <p:nvPr/>
          </p:nvSpPr>
          <p:spPr>
            <a:xfrm>
              <a:off x="3857313" y="1457077"/>
              <a:ext cx="203586" cy="126137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790"/>
                </a:spcAft>
              </a:pPr>
              <a:r>
                <a:rPr lang="en-US" sz="1100" dirty="0">
                  <a:solidFill>
                    <a:schemeClr val="bg1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 </a:t>
              </a:r>
              <a:endParaRPr lang="en-US" sz="1100" dirty="0">
                <a:solidFill>
                  <a:schemeClr val="bg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59" name="Rectangle 58"/>
            <p:cNvSpPr/>
            <p:nvPr/>
          </p:nvSpPr>
          <p:spPr>
            <a:xfrm>
              <a:off x="3853088" y="1881545"/>
              <a:ext cx="203586" cy="126137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790"/>
                </a:spcAft>
              </a:pPr>
              <a:r>
                <a:rPr lang="en-US" sz="1100" dirty="0">
                  <a:solidFill>
                    <a:schemeClr val="bg1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 </a:t>
              </a:r>
              <a:endParaRPr lang="en-US" sz="1100" dirty="0">
                <a:solidFill>
                  <a:schemeClr val="bg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60" name="Rectangle 59"/>
            <p:cNvSpPr/>
            <p:nvPr/>
          </p:nvSpPr>
          <p:spPr>
            <a:xfrm>
              <a:off x="3857634" y="1252208"/>
              <a:ext cx="203586" cy="126137"/>
            </a:xfrm>
            <a:prstGeom prst="rect">
              <a:avLst/>
            </a:prstGeom>
            <a:solidFill>
              <a:srgbClr val="C0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790"/>
                </a:spcAft>
              </a:pPr>
              <a:r>
                <a:rPr lang="en-US" sz="1100" dirty="0">
                  <a:solidFill>
                    <a:schemeClr val="bg1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 </a:t>
              </a:r>
              <a:endParaRPr lang="en-US" sz="1100" dirty="0">
                <a:solidFill>
                  <a:schemeClr val="bg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61" name="TextBox 88"/>
            <p:cNvSpPr txBox="1"/>
            <p:nvPr/>
          </p:nvSpPr>
          <p:spPr>
            <a:xfrm>
              <a:off x="4029904" y="1164678"/>
              <a:ext cx="15840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Control media</a:t>
              </a:r>
              <a:endParaRPr lang="en-US" sz="1100" dirty="0">
                <a:latin typeface="Helvetica" panose="020B0604020202020204" pitchFamily="34" charset="0"/>
                <a:ea typeface="Times New Roman"/>
                <a:cs typeface="Helvetica" panose="020B0604020202020204" pitchFamily="34" charset="0"/>
              </a:endParaRPr>
            </a:p>
          </p:txBody>
        </p:sp>
        <p:sp>
          <p:nvSpPr>
            <p:cNvPr id="62" name="Rectangle 61"/>
            <p:cNvSpPr/>
            <p:nvPr/>
          </p:nvSpPr>
          <p:spPr>
            <a:xfrm>
              <a:off x="3857313" y="1676637"/>
              <a:ext cx="203586" cy="126137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790"/>
                </a:spcAft>
              </a:pPr>
              <a:r>
                <a:rPr lang="en-US" sz="1100" dirty="0">
                  <a:solidFill>
                    <a:schemeClr val="bg1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 </a:t>
              </a:r>
              <a:endParaRPr lang="en-US" sz="1100" dirty="0">
                <a:solidFill>
                  <a:schemeClr val="bg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63" name="Rectangle 62"/>
            <p:cNvSpPr/>
            <p:nvPr/>
          </p:nvSpPr>
          <p:spPr>
            <a:xfrm>
              <a:off x="3853088" y="2106261"/>
              <a:ext cx="203586" cy="126137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790"/>
                </a:spcAft>
              </a:pPr>
              <a:r>
                <a:rPr lang="en-US" sz="1100" dirty="0">
                  <a:solidFill>
                    <a:schemeClr val="bg1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 </a:t>
              </a:r>
              <a:endParaRPr lang="en-US" sz="1100" dirty="0">
                <a:solidFill>
                  <a:schemeClr val="bg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</p:grpSp>
      <p:sp>
        <p:nvSpPr>
          <p:cNvPr id="52" name="TextBox 107"/>
          <p:cNvSpPr txBox="1"/>
          <p:nvPr/>
        </p:nvSpPr>
        <p:spPr>
          <a:xfrm>
            <a:off x="32888" y="170594"/>
            <a:ext cx="28841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Shahriary et al.- Supplementary Figure 5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294858" y="535280"/>
            <a:ext cx="3415768" cy="2332228"/>
            <a:chOff x="294858" y="535280"/>
            <a:chExt cx="3415768" cy="2332228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94969383"/>
                </p:ext>
              </p:extLst>
            </p:nvPr>
          </p:nvGraphicFramePr>
          <p:xfrm>
            <a:off x="734343" y="960959"/>
            <a:ext cx="2976283" cy="17998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6" name="Group 5"/>
            <p:cNvGrpSpPr/>
            <p:nvPr/>
          </p:nvGrpSpPr>
          <p:grpSpPr>
            <a:xfrm>
              <a:off x="1210744" y="996478"/>
              <a:ext cx="2206565" cy="545836"/>
              <a:chOff x="914400" y="337120"/>
              <a:chExt cx="1760386" cy="742235"/>
            </a:xfrm>
          </p:grpSpPr>
          <p:grpSp>
            <p:nvGrpSpPr>
              <p:cNvPr id="15" name="Group 14"/>
              <p:cNvGrpSpPr/>
              <p:nvPr/>
            </p:nvGrpSpPr>
            <p:grpSpPr>
              <a:xfrm>
                <a:off x="914400" y="533401"/>
                <a:ext cx="1760386" cy="76200"/>
                <a:chOff x="914400" y="762000"/>
                <a:chExt cx="1760385" cy="76200"/>
              </a:xfrm>
            </p:grpSpPr>
            <p:cxnSp>
              <p:nvCxnSpPr>
                <p:cNvPr id="17" name="Straight Connector 16"/>
                <p:cNvCxnSpPr/>
                <p:nvPr/>
              </p:nvCxnSpPr>
              <p:spPr>
                <a:xfrm>
                  <a:off x="914400" y="762000"/>
                  <a:ext cx="17526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Straight Connector 17"/>
                <p:cNvCxnSpPr/>
                <p:nvPr/>
              </p:nvCxnSpPr>
              <p:spPr>
                <a:xfrm>
                  <a:off x="914400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Connector 18"/>
                <p:cNvCxnSpPr/>
                <p:nvPr/>
              </p:nvCxnSpPr>
              <p:spPr>
                <a:xfrm>
                  <a:off x="2674785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" name="TextBox 3"/>
              <p:cNvSpPr txBox="1"/>
              <p:nvPr/>
            </p:nvSpPr>
            <p:spPr>
              <a:xfrm>
                <a:off x="1601361" y="337120"/>
                <a:ext cx="440290" cy="742235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CA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***</a:t>
                </a:r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>
              <a:off x="294858" y="535280"/>
              <a:ext cx="35618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a)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-595945" y="1559048"/>
              <a:ext cx="2201423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Fold change in NPC migration</a:t>
              </a:r>
            </a:p>
            <a:p>
              <a:pPr algn="ctr"/>
              <a:r>
                <a:rPr lang="en-US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 normalized to control media</a:t>
              </a:r>
            </a:p>
          </p:txBody>
        </p:sp>
        <p:grpSp>
          <p:nvGrpSpPr>
            <p:cNvPr id="53" name="Group 52"/>
            <p:cNvGrpSpPr/>
            <p:nvPr/>
          </p:nvGrpSpPr>
          <p:grpSpPr>
            <a:xfrm>
              <a:off x="1702518" y="1204693"/>
              <a:ext cx="1643630" cy="545836"/>
              <a:chOff x="914400" y="337120"/>
              <a:chExt cx="1760386" cy="742235"/>
            </a:xfrm>
          </p:grpSpPr>
          <p:grpSp>
            <p:nvGrpSpPr>
              <p:cNvPr id="64" name="Group 63"/>
              <p:cNvGrpSpPr/>
              <p:nvPr/>
            </p:nvGrpSpPr>
            <p:grpSpPr>
              <a:xfrm>
                <a:off x="914400" y="533401"/>
                <a:ext cx="1760386" cy="76200"/>
                <a:chOff x="914400" y="762000"/>
                <a:chExt cx="1760385" cy="76200"/>
              </a:xfrm>
            </p:grpSpPr>
            <p:cxnSp>
              <p:nvCxnSpPr>
                <p:cNvPr id="66" name="Straight Connector 65"/>
                <p:cNvCxnSpPr/>
                <p:nvPr/>
              </p:nvCxnSpPr>
              <p:spPr>
                <a:xfrm>
                  <a:off x="914400" y="762000"/>
                  <a:ext cx="17526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Straight Connector 66"/>
                <p:cNvCxnSpPr/>
                <p:nvPr/>
              </p:nvCxnSpPr>
              <p:spPr>
                <a:xfrm>
                  <a:off x="914400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Straight Connector 67"/>
                <p:cNvCxnSpPr/>
                <p:nvPr/>
              </p:nvCxnSpPr>
              <p:spPr>
                <a:xfrm>
                  <a:off x="2674785" y="762000"/>
                  <a:ext cx="0" cy="76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5" name="TextBox 3"/>
              <p:cNvSpPr txBox="1"/>
              <p:nvPr/>
            </p:nvSpPr>
            <p:spPr>
              <a:xfrm>
                <a:off x="1601361" y="337120"/>
                <a:ext cx="440290" cy="742235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CA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**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065469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77</TotalTime>
  <Words>53</Words>
  <Application>Microsoft Office PowerPoint</Application>
  <PresentationFormat>Custom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 Theme</vt:lpstr>
      <vt:lpstr>PowerPoint Presentation</vt:lpstr>
    </vt:vector>
  </TitlesOfParts>
  <Company>MRT www.Win2Farsi.c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1015</cp:revision>
  <cp:lastPrinted>2019-02-02T05:56:56Z</cp:lastPrinted>
  <dcterms:created xsi:type="dcterms:W3CDTF">2018-08-01T14:08:28Z</dcterms:created>
  <dcterms:modified xsi:type="dcterms:W3CDTF">2019-02-14T00:53:39Z</dcterms:modified>
</cp:coreProperties>
</file>